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5" r:id="rId2"/>
    <p:sldId id="286" r:id="rId3"/>
    <p:sldId id="287" r:id="rId4"/>
    <p:sldId id="290" r:id="rId5"/>
    <p:sldId id="291" r:id="rId6"/>
    <p:sldId id="292" r:id="rId7"/>
    <p:sldId id="293" r:id="rId8"/>
    <p:sldId id="294" r:id="rId9"/>
    <p:sldId id="295" r:id="rId10"/>
    <p:sldId id="297" r:id="rId11"/>
    <p:sldId id="299" r:id="rId12"/>
    <p:sldId id="298" r:id="rId13"/>
  </p:sldIdLst>
  <p:sldSz cx="12192000" cy="6858000"/>
  <p:notesSz cx="6807200" cy="99393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00FF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5" autoAdjust="0"/>
    <p:restoredTop sz="94660"/>
  </p:normalViewPr>
  <p:slideViewPr>
    <p:cSldViewPr snapToGrid="0">
      <p:cViewPr varScale="1">
        <p:scale>
          <a:sx n="60" d="100"/>
          <a:sy n="60" d="100"/>
        </p:scale>
        <p:origin x="96" y="11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709EBD1-59C6-E99A-7C11-740B6F92D7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2DD212D2-FF5B-1AEA-83C1-DC48E464E7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CA5CED6-E9FD-8972-6D1C-A49CB39A9C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A27CC-F68C-4A29-8CB9-D0E78E580290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C419ACE-D463-66AD-6CEA-189B6DA335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7136C12-E7DC-F658-A045-8AC431763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B972A-1DE5-4218-8957-A6129D48CE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9182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A8D1459-DFC3-AB70-9144-4EE6426BE4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3DD3B1C-D646-7DED-DAD1-175048DFA3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0C05518-8927-2B11-535C-5EE78DD874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A27CC-F68C-4A29-8CB9-D0E78E580290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4E83D20-C014-42DF-36DF-18F341B09B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E361D8B-A3B3-E19B-1E16-7DEDD0EF05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B972A-1DE5-4218-8957-A6129D48CE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53548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AEB4E748-E5D0-3B9A-55A8-FD4F0036B6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FBDFAFCB-84DA-8CDB-FF58-DD56CCCCF0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369D86A-AF6A-1F5F-FB5A-E61AD79577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A27CC-F68C-4A29-8CB9-D0E78E580290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8F392F6-3CF8-5EEE-49F9-3AE8F864ED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CC29D18-8EEF-8D7D-F6EB-5A536EC128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B972A-1DE5-4218-8957-A6129D48CE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60461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F3A7439-663A-1A45-F6F0-27C091080B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0D52C2C-021C-3E43-3E41-7A7662D4E5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17C58B9-2469-62BF-C023-C8490AF4EC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A27CC-F68C-4A29-8CB9-D0E78E580290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4095E2E-756A-3457-58BD-1E8E4A0149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77252B5-708D-C926-CFEE-91FC7E2A1C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B972A-1DE5-4218-8957-A6129D48CE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05461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AFDE6E6-D8F2-1942-9759-2B2DD22C37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539937E-DFBC-AADB-3AA7-7AE9736777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AA8599F-7A47-0BB0-BE31-2450E5E44D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A27CC-F68C-4A29-8CB9-D0E78E580290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A6848FA-E7C4-967D-D67B-19CA6B0EFB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70FF331-1848-A669-2476-82E11779FE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B972A-1DE5-4218-8957-A6129D48CE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85887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1810940-5BC1-FA91-9360-CB63A2409D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71C5383-0B99-2918-3AE8-B3183A3A16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B071F42B-FD67-516E-66E9-8E75D18B6B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116EFC9-5DD9-EAFC-9B39-1D1602D3FB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A27CC-F68C-4A29-8CB9-D0E78E580290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2A43508-3D1E-D34D-3C0C-538D1ED540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8D97B80-60EB-18C1-B53E-EC0B21D100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B972A-1DE5-4218-8957-A6129D48CE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35317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68F6E73-EA6B-7009-420A-284C426148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9BC8B67-BD27-C537-7CA8-903714881A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DC7661A-47D1-130B-9285-C8167EDBA3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970AE29A-EE09-DEF5-8D3A-AA4BF96096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21651327-C9D1-8DA4-F62C-9AD61B6C61F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1A9623C6-3E9C-B658-38C4-E2AB9A5421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A27CC-F68C-4A29-8CB9-D0E78E580290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FDBDE421-ECD2-D13C-9334-A8B5A98488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00A819BC-2144-CBEB-3C69-050A472C08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B972A-1DE5-4218-8957-A6129D48CE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92083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8BF890C-A1F5-4899-C6A5-24D2672D46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FE258131-AFB5-3CB1-E07C-5E8D77CEE8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A27CC-F68C-4A29-8CB9-D0E78E580290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C0D938D1-7982-3B48-1B35-C48895E316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E7108059-64FC-A9B4-86DB-E53C2EBAE0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B972A-1DE5-4218-8957-A6129D48CE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2460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0D1E6A5F-DBF5-1219-3465-25DE3DA470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A27CC-F68C-4A29-8CB9-D0E78E580290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8BD28520-C107-6AE0-A5F4-1791504D86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9F870D1D-9917-C763-8BB0-CC3C84CA3C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B972A-1DE5-4218-8957-A6129D48CE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28653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43C43EA-ABFB-1E3C-74C8-DB5EC14804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060C38C-D531-C670-CB75-F1DFF04273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E3D7F3A-46A3-E16A-53B5-3FA1FBF0EF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E2C2464-26FC-943B-12C0-8911EA2426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A27CC-F68C-4A29-8CB9-D0E78E580290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7844436-0609-335A-5FD1-4B31130516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7A04C58-5167-9845-837C-1273B85AEF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B972A-1DE5-4218-8957-A6129D48CE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19790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99A4D1F-3288-2621-A468-F0C4C256DD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038FD15E-8A75-5E58-4BEB-B7DB2E5711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12F311B4-2DB7-03BD-0EB9-C5DA856A48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58595C19-1FD2-5E29-071B-3F911C48AF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EA27CC-F68C-4A29-8CB9-D0E78E580290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4826A68-34F0-9086-05CF-9C9EAB01BE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85A32626-5D42-D0E2-6298-ACEDDE2844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FB972A-1DE5-4218-8957-A6129D48CE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05864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EBBE437D-0F3F-F307-61E9-7641F382FA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0968D60-DAB0-A79A-BEFF-C59DB91960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DF406DF-EFD8-84DC-8933-A99DEA57A04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EA27CC-F68C-4A29-8CB9-D0E78E580290}" type="datetimeFigureOut">
              <a:rPr lang="ko-KR" altLang="en-US" smtClean="0"/>
              <a:t>2024-09-30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9A1FEC3-0479-2BA0-EB53-A56A10B64C4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D5FCAB6-075C-4EE8-CE9A-53F7C76F07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FB972A-1DE5-4218-8957-A6129D48CED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0151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microsoft.com/office/2007/relationships/hdphoto" Target="../media/hdphoto1.wdp"/></Relationships>
</file>

<file path=ppt/slides/_rels/slide11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microsoft.com/office/2007/relationships/hdphoto" Target="../media/hdphoto3.wdp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>
            <a:extLst>
              <a:ext uri="{FF2B5EF4-FFF2-40B4-BE49-F238E27FC236}">
                <a16:creationId xmlns:a16="http://schemas.microsoft.com/office/drawing/2014/main" id="{8D21746B-FAF0-B7B4-0ECC-9E67369F3EF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430335">
            <a:off x="4133133" y="225631"/>
            <a:ext cx="6909629" cy="6858000"/>
          </a:xfrm>
          <a:prstGeom prst="rect">
            <a:avLst/>
          </a:prstGeom>
        </p:spPr>
      </p:pic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5C146D07-C711-63A2-3739-F15F51DA708E}"/>
              </a:ext>
            </a:extLst>
          </p:cNvPr>
          <p:cNvCxnSpPr>
            <a:cxnSpLocks/>
          </p:cNvCxnSpPr>
          <p:nvPr/>
        </p:nvCxnSpPr>
        <p:spPr>
          <a:xfrm rot="13202042" flipV="1">
            <a:off x="11317669" y="6355444"/>
            <a:ext cx="324000" cy="864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81F1276-C5A9-1AA9-5EC0-D4300D42C998}"/>
              </a:ext>
            </a:extLst>
          </p:cNvPr>
          <p:cNvSpPr txBox="1"/>
          <p:nvPr/>
        </p:nvSpPr>
        <p:spPr>
          <a:xfrm flipH="1">
            <a:off x="-2" y="0"/>
            <a:ext cx="2349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E15-E18 control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95183502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>
            <a:extLst>
              <a:ext uri="{FF2B5EF4-FFF2-40B4-BE49-F238E27FC236}">
                <a16:creationId xmlns:a16="http://schemas.microsoft.com/office/drawing/2014/main" id="{4F512F2A-E343-C42F-5DF9-5B6C0E7B25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5FCA657A-91A1-0E14-ECF8-7D2D7FD9603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pic>
        <p:nvPicPr>
          <p:cNvPr id="76" name="그림 75">
            <a:extLst>
              <a:ext uri="{FF2B5EF4-FFF2-40B4-BE49-F238E27FC236}">
                <a16:creationId xmlns:a16="http://schemas.microsoft.com/office/drawing/2014/main" id="{13CF0AFB-5D57-B9AF-28A1-BCC3670E54D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5E094213-CAE1-AED0-81B2-5A62EDB01F9B}"/>
              </a:ext>
            </a:extLst>
          </p:cNvPr>
          <p:cNvSpPr/>
          <p:nvPr/>
        </p:nvSpPr>
        <p:spPr>
          <a:xfrm>
            <a:off x="6740525" y="1219200"/>
            <a:ext cx="1440000" cy="1440000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cxnSp>
        <p:nvCxnSpPr>
          <p:cNvPr id="3" name="직선 연결선 2">
            <a:extLst>
              <a:ext uri="{FF2B5EF4-FFF2-40B4-BE49-F238E27FC236}">
                <a16:creationId xmlns:a16="http://schemas.microsoft.com/office/drawing/2014/main" id="{2D46ADB1-02F5-27BD-74AA-6023EAB31575}"/>
              </a:ext>
            </a:extLst>
          </p:cNvPr>
          <p:cNvCxnSpPr/>
          <p:nvPr/>
        </p:nvCxnSpPr>
        <p:spPr>
          <a:xfrm>
            <a:off x="2838450" y="6553200"/>
            <a:ext cx="82800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2988863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>
            <a:extLst>
              <a:ext uri="{FF2B5EF4-FFF2-40B4-BE49-F238E27FC236}">
                <a16:creationId xmlns:a16="http://schemas.microsoft.com/office/drawing/2014/main" id="{D0D1D805-B46D-19FB-FCCD-FF6B0AC57C7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pic>
        <p:nvPicPr>
          <p:cNvPr id="4" name="그림 3">
            <a:extLst>
              <a:ext uri="{FF2B5EF4-FFF2-40B4-BE49-F238E27FC236}">
                <a16:creationId xmlns:a16="http://schemas.microsoft.com/office/drawing/2014/main" id="{063F8A0B-0D91-FA09-9A4F-74AC6B57A95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F2522CD4-7B04-8056-ADCD-8D5C8BCC3ED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679891" y="0"/>
            <a:ext cx="6832218" cy="6858000"/>
          </a:xfrm>
          <a:prstGeom prst="rect">
            <a:avLst/>
          </a:prstGeom>
        </p:spPr>
      </p:pic>
      <p:cxnSp>
        <p:nvCxnSpPr>
          <p:cNvPr id="12" name="직선 연결선 11">
            <a:extLst>
              <a:ext uri="{FF2B5EF4-FFF2-40B4-BE49-F238E27FC236}">
                <a16:creationId xmlns:a16="http://schemas.microsoft.com/office/drawing/2014/main" id="{ADAA47FE-55B0-96CD-4495-E92C0E561B92}"/>
              </a:ext>
            </a:extLst>
          </p:cNvPr>
          <p:cNvCxnSpPr/>
          <p:nvPr/>
        </p:nvCxnSpPr>
        <p:spPr>
          <a:xfrm>
            <a:off x="2838450" y="6590688"/>
            <a:ext cx="86677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직사각형 1">
            <a:extLst>
              <a:ext uri="{FF2B5EF4-FFF2-40B4-BE49-F238E27FC236}">
                <a16:creationId xmlns:a16="http://schemas.microsoft.com/office/drawing/2014/main" id="{15D6EA35-E880-A3BD-196F-010B07E799EF}"/>
              </a:ext>
            </a:extLst>
          </p:cNvPr>
          <p:cNvSpPr/>
          <p:nvPr/>
        </p:nvSpPr>
        <p:spPr>
          <a:xfrm>
            <a:off x="7988300" y="4569052"/>
            <a:ext cx="1440000" cy="1440000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14213241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>
            <a:extLst>
              <a:ext uri="{FF2B5EF4-FFF2-40B4-BE49-F238E27FC236}">
                <a16:creationId xmlns:a16="http://schemas.microsoft.com/office/drawing/2014/main" id="{B9461327-BAE0-83CE-F7A1-B4D680D30BF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9891" y="-285750"/>
            <a:ext cx="6832218" cy="6858000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E1FAF42E-91A3-1758-B26B-CAD564E5312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79891" y="-272325"/>
            <a:ext cx="6832218" cy="6858000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461B9482-DAC4-7AEF-4A19-1705B00FAF4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79891" y="-285750"/>
            <a:ext cx="6832218" cy="6858000"/>
          </a:xfrm>
          <a:prstGeom prst="rect">
            <a:avLst/>
          </a:prstGeom>
        </p:spPr>
      </p:pic>
      <p:sp>
        <p:nvSpPr>
          <p:cNvPr id="2" name="직사각형 1">
            <a:extLst>
              <a:ext uri="{FF2B5EF4-FFF2-40B4-BE49-F238E27FC236}">
                <a16:creationId xmlns:a16="http://schemas.microsoft.com/office/drawing/2014/main" id="{27E3732E-B838-0DC3-6B97-F1E77C215D45}"/>
              </a:ext>
            </a:extLst>
          </p:cNvPr>
          <p:cNvSpPr/>
          <p:nvPr/>
        </p:nvSpPr>
        <p:spPr>
          <a:xfrm>
            <a:off x="5376000" y="1051650"/>
            <a:ext cx="1440000" cy="1440000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pic>
        <p:nvPicPr>
          <p:cNvPr id="7" name="그림 6">
            <a:extLst>
              <a:ext uri="{FF2B5EF4-FFF2-40B4-BE49-F238E27FC236}">
                <a16:creationId xmlns:a16="http://schemas.microsoft.com/office/drawing/2014/main" id="{83562D1D-EEA0-3315-9942-E69DC4717A9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38587" y="1271587"/>
            <a:ext cx="1080000" cy="1080000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63F9194B-39E4-FA56-8A3B-00AABB0A9F0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38587" y="1266825"/>
            <a:ext cx="1080000" cy="1082384"/>
          </a:xfrm>
          <a:prstGeom prst="rect">
            <a:avLst/>
          </a:prstGeom>
        </p:spPr>
      </p:pic>
      <p:pic>
        <p:nvPicPr>
          <p:cNvPr id="11" name="그림 10">
            <a:extLst>
              <a:ext uri="{FF2B5EF4-FFF2-40B4-BE49-F238E27FC236}">
                <a16:creationId xmlns:a16="http://schemas.microsoft.com/office/drawing/2014/main" id="{BD747C95-7468-1A92-8CED-37F3509375F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38587" y="1271587"/>
            <a:ext cx="1080000" cy="10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38947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그림 12">
            <a:extLst>
              <a:ext uri="{FF2B5EF4-FFF2-40B4-BE49-F238E27FC236}">
                <a16:creationId xmlns:a16="http://schemas.microsoft.com/office/drawing/2014/main" id="{EA452340-A2C5-824F-8F82-3FBEC70D3C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430335">
            <a:off x="4133133" y="225631"/>
            <a:ext cx="6909629" cy="6858000"/>
          </a:xfrm>
          <a:prstGeom prst="rect">
            <a:avLst/>
          </a:prstGeom>
        </p:spPr>
      </p:pic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5C146D07-C711-63A2-3739-F15F51DA708E}"/>
              </a:ext>
            </a:extLst>
          </p:cNvPr>
          <p:cNvCxnSpPr>
            <a:cxnSpLocks/>
          </p:cNvCxnSpPr>
          <p:nvPr/>
        </p:nvCxnSpPr>
        <p:spPr>
          <a:xfrm rot="13202042" flipV="1">
            <a:off x="11317669" y="6355444"/>
            <a:ext cx="324000" cy="864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81F1276-C5A9-1AA9-5EC0-D4300D42C998}"/>
              </a:ext>
            </a:extLst>
          </p:cNvPr>
          <p:cNvSpPr txBox="1"/>
          <p:nvPr/>
        </p:nvSpPr>
        <p:spPr>
          <a:xfrm flipH="1">
            <a:off x="-2" y="0"/>
            <a:ext cx="2349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E15-E18 control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9928637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그림 14">
            <a:extLst>
              <a:ext uri="{FF2B5EF4-FFF2-40B4-BE49-F238E27FC236}">
                <a16:creationId xmlns:a16="http://schemas.microsoft.com/office/drawing/2014/main" id="{F874B98E-7D29-CFB6-AE44-32F01548D9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430335">
            <a:off x="4133133" y="225631"/>
            <a:ext cx="6909629" cy="6858000"/>
          </a:xfrm>
          <a:prstGeom prst="rect">
            <a:avLst/>
          </a:prstGeom>
        </p:spPr>
      </p:pic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5C146D07-C711-63A2-3739-F15F51DA708E}"/>
              </a:ext>
            </a:extLst>
          </p:cNvPr>
          <p:cNvCxnSpPr>
            <a:cxnSpLocks/>
          </p:cNvCxnSpPr>
          <p:nvPr/>
        </p:nvCxnSpPr>
        <p:spPr>
          <a:xfrm rot="13202042" flipV="1">
            <a:off x="11317669" y="6355444"/>
            <a:ext cx="324000" cy="864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81F1276-C5A9-1AA9-5EC0-D4300D42C998}"/>
              </a:ext>
            </a:extLst>
          </p:cNvPr>
          <p:cNvSpPr txBox="1"/>
          <p:nvPr/>
        </p:nvSpPr>
        <p:spPr>
          <a:xfrm flipH="1">
            <a:off x="-2" y="0"/>
            <a:ext cx="2349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E15-E18 control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4255728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207AB961-BCB1-E690-C7F0-4552332CC4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788298">
            <a:off x="3448707" y="142503"/>
            <a:ext cx="6909629" cy="6858000"/>
          </a:xfrm>
          <a:prstGeom prst="rect">
            <a:avLst/>
          </a:prstGeom>
        </p:spPr>
      </p:pic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5C146D07-C711-63A2-3739-F15F51DA708E}"/>
              </a:ext>
            </a:extLst>
          </p:cNvPr>
          <p:cNvCxnSpPr>
            <a:cxnSpLocks/>
          </p:cNvCxnSpPr>
          <p:nvPr/>
        </p:nvCxnSpPr>
        <p:spPr>
          <a:xfrm rot="13202042" flipV="1">
            <a:off x="11317669" y="6355444"/>
            <a:ext cx="324000" cy="864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81F1276-C5A9-1AA9-5EC0-D4300D42C998}"/>
              </a:ext>
            </a:extLst>
          </p:cNvPr>
          <p:cNvSpPr txBox="1"/>
          <p:nvPr/>
        </p:nvSpPr>
        <p:spPr>
          <a:xfrm flipH="1">
            <a:off x="0" y="0"/>
            <a:ext cx="2349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E15-E18 p18o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828232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>
            <a:extLst>
              <a:ext uri="{FF2B5EF4-FFF2-40B4-BE49-F238E27FC236}">
                <a16:creationId xmlns:a16="http://schemas.microsoft.com/office/drawing/2014/main" id="{B7ECAC3E-8657-44C5-BFBD-579AD7BE3E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788298">
            <a:off x="3448707" y="142503"/>
            <a:ext cx="6909629" cy="6858000"/>
          </a:xfrm>
          <a:prstGeom prst="rect">
            <a:avLst/>
          </a:prstGeom>
        </p:spPr>
      </p:pic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5C146D07-C711-63A2-3739-F15F51DA708E}"/>
              </a:ext>
            </a:extLst>
          </p:cNvPr>
          <p:cNvCxnSpPr>
            <a:cxnSpLocks/>
          </p:cNvCxnSpPr>
          <p:nvPr/>
        </p:nvCxnSpPr>
        <p:spPr>
          <a:xfrm rot="13202042" flipV="1">
            <a:off x="11317669" y="6355444"/>
            <a:ext cx="324000" cy="864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81F1276-C5A9-1AA9-5EC0-D4300D42C998}"/>
              </a:ext>
            </a:extLst>
          </p:cNvPr>
          <p:cNvSpPr txBox="1"/>
          <p:nvPr/>
        </p:nvSpPr>
        <p:spPr>
          <a:xfrm flipH="1">
            <a:off x="0" y="0"/>
            <a:ext cx="2349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E15-E18 p18o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9880725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>
            <a:extLst>
              <a:ext uri="{FF2B5EF4-FFF2-40B4-BE49-F238E27FC236}">
                <a16:creationId xmlns:a16="http://schemas.microsoft.com/office/drawing/2014/main" id="{DD14757D-DA88-367A-331A-1D760432AE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788298">
            <a:off x="3448707" y="142503"/>
            <a:ext cx="6909629" cy="6858000"/>
          </a:xfrm>
          <a:prstGeom prst="rect">
            <a:avLst/>
          </a:prstGeom>
        </p:spPr>
      </p:pic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5C146D07-C711-63A2-3739-F15F51DA708E}"/>
              </a:ext>
            </a:extLst>
          </p:cNvPr>
          <p:cNvCxnSpPr>
            <a:cxnSpLocks/>
          </p:cNvCxnSpPr>
          <p:nvPr/>
        </p:nvCxnSpPr>
        <p:spPr>
          <a:xfrm rot="13202042" flipV="1">
            <a:off x="11317669" y="6355444"/>
            <a:ext cx="324000" cy="864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81F1276-C5A9-1AA9-5EC0-D4300D42C998}"/>
              </a:ext>
            </a:extLst>
          </p:cNvPr>
          <p:cNvSpPr txBox="1"/>
          <p:nvPr/>
        </p:nvSpPr>
        <p:spPr>
          <a:xfrm flipH="1">
            <a:off x="0" y="0"/>
            <a:ext cx="2349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E15-E18 p18o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27427021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1B7F1FB4-78D3-F58B-CBD6-BDC7B0AFA5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301882">
            <a:off x="1917285" y="-317501"/>
            <a:ext cx="6909629" cy="6858000"/>
          </a:xfrm>
          <a:prstGeom prst="rect">
            <a:avLst/>
          </a:prstGeom>
        </p:spPr>
      </p:pic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5C146D07-C711-63A2-3739-F15F51DA708E}"/>
              </a:ext>
            </a:extLst>
          </p:cNvPr>
          <p:cNvCxnSpPr>
            <a:cxnSpLocks/>
          </p:cNvCxnSpPr>
          <p:nvPr/>
        </p:nvCxnSpPr>
        <p:spPr>
          <a:xfrm rot="13202042" flipV="1">
            <a:off x="11317669" y="6355444"/>
            <a:ext cx="324000" cy="864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81F1276-C5A9-1AA9-5EC0-D4300D42C998}"/>
              </a:ext>
            </a:extLst>
          </p:cNvPr>
          <p:cNvSpPr txBox="1"/>
          <p:nvPr/>
        </p:nvSpPr>
        <p:spPr>
          <a:xfrm flipH="1">
            <a:off x="-2" y="0"/>
            <a:ext cx="2349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E15-E18 Dlx2o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765936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>
            <a:extLst>
              <a:ext uri="{FF2B5EF4-FFF2-40B4-BE49-F238E27FC236}">
                <a16:creationId xmlns:a16="http://schemas.microsoft.com/office/drawing/2014/main" id="{34789136-16AF-0304-D865-6DCC4F8638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301882">
            <a:off x="1917285" y="-317501"/>
            <a:ext cx="6909629" cy="6858000"/>
          </a:xfrm>
          <a:prstGeom prst="rect">
            <a:avLst/>
          </a:prstGeom>
        </p:spPr>
      </p:pic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5C146D07-C711-63A2-3739-F15F51DA708E}"/>
              </a:ext>
            </a:extLst>
          </p:cNvPr>
          <p:cNvCxnSpPr>
            <a:cxnSpLocks/>
          </p:cNvCxnSpPr>
          <p:nvPr/>
        </p:nvCxnSpPr>
        <p:spPr>
          <a:xfrm rot="13202042" flipV="1">
            <a:off x="11317669" y="6355444"/>
            <a:ext cx="324000" cy="864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81F1276-C5A9-1AA9-5EC0-D4300D42C998}"/>
              </a:ext>
            </a:extLst>
          </p:cNvPr>
          <p:cNvSpPr txBox="1"/>
          <p:nvPr/>
        </p:nvSpPr>
        <p:spPr>
          <a:xfrm flipH="1">
            <a:off x="-2" y="0"/>
            <a:ext cx="2349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E15-E18 Dlx2o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06377702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>
            <a:extLst>
              <a:ext uri="{FF2B5EF4-FFF2-40B4-BE49-F238E27FC236}">
                <a16:creationId xmlns:a16="http://schemas.microsoft.com/office/drawing/2014/main" id="{AFE2F9E0-1660-5FC7-58A6-E9BE8BEC5E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301882">
            <a:off x="1917285" y="-317501"/>
            <a:ext cx="6909629" cy="6858000"/>
          </a:xfrm>
          <a:prstGeom prst="rect">
            <a:avLst/>
          </a:prstGeom>
        </p:spPr>
      </p:pic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5C146D07-C711-63A2-3739-F15F51DA708E}"/>
              </a:ext>
            </a:extLst>
          </p:cNvPr>
          <p:cNvCxnSpPr>
            <a:cxnSpLocks/>
          </p:cNvCxnSpPr>
          <p:nvPr/>
        </p:nvCxnSpPr>
        <p:spPr>
          <a:xfrm rot="13202042" flipV="1">
            <a:off x="11317669" y="6355444"/>
            <a:ext cx="324000" cy="86400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81F1276-C5A9-1AA9-5EC0-D4300D42C998}"/>
              </a:ext>
            </a:extLst>
          </p:cNvPr>
          <p:cNvSpPr txBox="1"/>
          <p:nvPr/>
        </p:nvSpPr>
        <p:spPr>
          <a:xfrm flipH="1">
            <a:off x="-2" y="0"/>
            <a:ext cx="23495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E15-E18 Dlx2o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2406793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2</TotalTime>
  <Words>18</Words>
  <Application>Microsoft Office PowerPoint</Application>
  <PresentationFormat>와이드스크린</PresentationFormat>
  <Paragraphs>9</Paragraphs>
  <Slides>1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2</vt:i4>
      </vt:variant>
    </vt:vector>
  </HeadingPairs>
  <TitlesOfParts>
    <vt:vector size="15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 원영</dc:creator>
  <cp:lastModifiedBy>이 원영</cp:lastModifiedBy>
  <cp:revision>12</cp:revision>
  <cp:lastPrinted>2023-02-24T02:14:51Z</cp:lastPrinted>
  <dcterms:created xsi:type="dcterms:W3CDTF">2023-02-22T06:42:54Z</dcterms:created>
  <dcterms:modified xsi:type="dcterms:W3CDTF">2024-09-30T06:48:43Z</dcterms:modified>
</cp:coreProperties>
</file>